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0" r:id="rId2"/>
    <p:sldId id="269" r:id="rId3"/>
    <p:sldId id="271" r:id="rId4"/>
    <p:sldId id="274" r:id="rId5"/>
    <p:sldId id="272" r:id="rId6"/>
    <p:sldId id="27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33"/>
  </p:normalViewPr>
  <p:slideViewPr>
    <p:cSldViewPr snapToGrid="0" snapToObjects="1">
      <p:cViewPr varScale="1">
        <p:scale>
          <a:sx n="78" d="100"/>
          <a:sy n="78" d="100"/>
        </p:scale>
        <p:origin x="31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0363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1629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0257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0993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4919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2149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7922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6645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039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5717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6522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7D6F9-0D4A-3644-BC24-465708082AE2}" type="datetimeFigureOut">
              <a:rPr lang="de-DE" smtClean="0"/>
              <a:t>19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FBBEE-B15C-124F-8CEF-15109BB8C4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9641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820551FE-B695-E34B-BAFB-BD886441735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082" y="1972451"/>
            <a:ext cx="3136207" cy="4340288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A18DF8AF-C842-8846-9FF3-B50F1E34EF68}"/>
              </a:ext>
            </a:extLst>
          </p:cNvPr>
          <p:cNvSpPr txBox="1"/>
          <p:nvPr/>
        </p:nvSpPr>
        <p:spPr>
          <a:xfrm>
            <a:off x="76200" y="93133"/>
            <a:ext cx="2171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ure 1  </a:t>
            </a:r>
          </a:p>
        </p:txBody>
      </p:sp>
    </p:spTree>
    <p:extLst>
      <p:ext uri="{BB962C8B-B14F-4D97-AF65-F5344CB8AC3E}">
        <p14:creationId xmlns:p14="http://schemas.microsoft.com/office/powerpoint/2010/main" val="5370799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3D4A45D2-D32B-0040-B90D-AAA46136561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12"/>
          <a:stretch/>
        </p:blipFill>
        <p:spPr bwMode="auto">
          <a:xfrm>
            <a:off x="2183239" y="5140702"/>
            <a:ext cx="2128242" cy="20263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id="{71B9D969-F965-8847-9B53-2CA0911E31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231" y="1392969"/>
            <a:ext cx="2078500" cy="3690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E059CDD7-8A2C-AE4D-920F-2EEC247AB9CE}"/>
              </a:ext>
            </a:extLst>
          </p:cNvPr>
          <p:cNvSpPr txBox="1"/>
          <p:nvPr/>
        </p:nvSpPr>
        <p:spPr>
          <a:xfrm>
            <a:off x="76199" y="93133"/>
            <a:ext cx="1819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ure 2  </a:t>
            </a:r>
          </a:p>
        </p:txBody>
      </p:sp>
    </p:spTree>
    <p:extLst>
      <p:ext uri="{BB962C8B-B14F-4D97-AF65-F5344CB8AC3E}">
        <p14:creationId xmlns:p14="http://schemas.microsoft.com/office/powerpoint/2010/main" val="289102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4B8B7804-E228-0541-9808-0441A5AFB1C8}"/>
              </a:ext>
            </a:extLst>
          </p:cNvPr>
          <p:cNvSpPr txBox="1"/>
          <p:nvPr/>
        </p:nvSpPr>
        <p:spPr>
          <a:xfrm>
            <a:off x="76200" y="93133"/>
            <a:ext cx="2000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ure 3  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57D73D6A-C677-F647-AF84-52218C1591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6450" y="2005106"/>
            <a:ext cx="2705100" cy="35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76718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03359E30-AF76-4BC5-BA0B-33D5812AA913}"/>
              </a:ext>
            </a:extLst>
          </p:cNvPr>
          <p:cNvSpPr txBox="1"/>
          <p:nvPr/>
        </p:nvSpPr>
        <p:spPr>
          <a:xfrm>
            <a:off x="76199" y="93133"/>
            <a:ext cx="1933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ure 4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71C47186-76ED-4E4D-A6BD-F369EA37F2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974" y="958681"/>
            <a:ext cx="5797798" cy="21459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7853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D23A8541-1307-E143-9930-A1E9E903CB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2209" y="1241535"/>
            <a:ext cx="4090893" cy="49804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8CD581FA-4B5E-D24E-9788-DE2DD39EDC6F}"/>
              </a:ext>
            </a:extLst>
          </p:cNvPr>
          <p:cNvSpPr txBox="1"/>
          <p:nvPr/>
        </p:nvSpPr>
        <p:spPr>
          <a:xfrm>
            <a:off x="76199" y="93133"/>
            <a:ext cx="1933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ure 5</a:t>
            </a:r>
          </a:p>
        </p:txBody>
      </p:sp>
    </p:spTree>
    <p:extLst>
      <p:ext uri="{BB962C8B-B14F-4D97-AF65-F5344CB8AC3E}">
        <p14:creationId xmlns:p14="http://schemas.microsoft.com/office/powerpoint/2010/main" val="17597084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C3FFBB54-8C26-7843-8D1C-F3BCD87F5E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592"/>
          <a:stretch/>
        </p:blipFill>
        <p:spPr>
          <a:xfrm>
            <a:off x="2254250" y="2382669"/>
            <a:ext cx="2349500" cy="2260601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5295EE2E-DC47-1341-B479-1B5F779F2C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4250" y="4777890"/>
            <a:ext cx="2336800" cy="226060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AD91ABAD-7B5C-8A47-91E0-60C8700B9166}"/>
              </a:ext>
            </a:extLst>
          </p:cNvPr>
          <p:cNvSpPr txBox="1"/>
          <p:nvPr/>
        </p:nvSpPr>
        <p:spPr>
          <a:xfrm>
            <a:off x="76199" y="93133"/>
            <a:ext cx="1933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ure 6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4EF88E05-F68F-DB48-874D-8A7963BFE5EB}"/>
              </a:ext>
            </a:extLst>
          </p:cNvPr>
          <p:cNvSpPr txBox="1"/>
          <p:nvPr/>
        </p:nvSpPr>
        <p:spPr>
          <a:xfrm>
            <a:off x="2042307" y="2382670"/>
            <a:ext cx="4238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0E25F059-889E-5545-B6BF-F66EB7B0C962}"/>
              </a:ext>
            </a:extLst>
          </p:cNvPr>
          <p:cNvSpPr txBox="1"/>
          <p:nvPr/>
        </p:nvSpPr>
        <p:spPr>
          <a:xfrm>
            <a:off x="2042307" y="4799111"/>
            <a:ext cx="4238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4971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</Words>
  <Application>Microsoft Macintosh PowerPoint</Application>
  <PresentationFormat>A4-Papier (210 x 297 mm)</PresentationFormat>
  <Paragraphs>8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lorian Siegerist</dc:creator>
  <cp:lastModifiedBy>Florian Siegerist</cp:lastModifiedBy>
  <cp:revision>4</cp:revision>
  <dcterms:created xsi:type="dcterms:W3CDTF">2021-02-02T13:24:47Z</dcterms:created>
  <dcterms:modified xsi:type="dcterms:W3CDTF">2021-03-19T11:17:02Z</dcterms:modified>
</cp:coreProperties>
</file>